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Terbinafin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593162211940083E-2"/>
          <c:y val="2.2226496497098167E-2"/>
          <c:w val="0.84626697925874916"/>
          <c:h val="0.788985727929047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D$22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E$23:$E$37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18.130362907884599</c:v>
                  </c:pt>
                  <c:pt idx="7">
                    <c:v>13.597772180913447</c:v>
                  </c:pt>
                  <c:pt idx="8">
                    <c:v>9.4711184671855282</c:v>
                  </c:pt>
                  <c:pt idx="9">
                    <c:v>26.646935501059652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</c:numCache>
              </c:numRef>
            </c:plus>
            <c:minus>
              <c:numRef>
                <c:f>Graph!$E$23:$E$37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18.130362907884599</c:v>
                  </c:pt>
                  <c:pt idx="7">
                    <c:v>13.597772180913447</c:v>
                  </c:pt>
                  <c:pt idx="8">
                    <c:v>9.4711184671855282</c:v>
                  </c:pt>
                  <c:pt idx="9">
                    <c:v>26.646935501059652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 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3:$D$37</c:f>
              <c:numCache>
                <c:formatCode>0.0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0.923076923076923</c:v>
                </c:pt>
                <c:pt idx="7">
                  <c:v>15.692307692307693</c:v>
                </c:pt>
                <c:pt idx="8">
                  <c:v>10.931899641577061</c:v>
                </c:pt>
                <c:pt idx="9">
                  <c:v>30.76923076923077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0A3-4C61-BADD-AFE2708297C0}"/>
            </c:ext>
          </c:extLst>
        </c:ser>
        <c:ser>
          <c:idx val="2"/>
          <c:order val="1"/>
          <c:tx>
            <c:strRef>
              <c:f>Graph!$F$22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G$23:$G$37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1.2435236567161125</c:v>
                  </c:pt>
                  <c:pt idx="7">
                    <c:v>2.0313130584962416</c:v>
                  </c:pt>
                  <c:pt idx="8">
                    <c:v>0.49664539285129261</c:v>
                  </c:pt>
                  <c:pt idx="9">
                    <c:v>2.2205779584216421</c:v>
                  </c:pt>
                  <c:pt idx="10">
                    <c:v>0.46453469934797509</c:v>
                  </c:pt>
                  <c:pt idx="11">
                    <c:v>0.46453469934797509</c:v>
                  </c:pt>
                  <c:pt idx="12">
                    <c:v>0</c:v>
                  </c:pt>
                  <c:pt idx="13">
                    <c:v>2.061965247105805</c:v>
                  </c:pt>
                  <c:pt idx="14">
                    <c:v>1.0322993318843874</c:v>
                  </c:pt>
                </c:numCache>
              </c:numRef>
            </c:plus>
            <c:minus>
              <c:numRef>
                <c:f>Graph!$G$23:$G$37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1.2435236567161125</c:v>
                  </c:pt>
                  <c:pt idx="7">
                    <c:v>2.0313130584962416</c:v>
                  </c:pt>
                  <c:pt idx="8">
                    <c:v>0.49664539285129261</c:v>
                  </c:pt>
                  <c:pt idx="9">
                    <c:v>2.2205779584216421</c:v>
                  </c:pt>
                  <c:pt idx="10">
                    <c:v>0.46453469934797509</c:v>
                  </c:pt>
                  <c:pt idx="11">
                    <c:v>0.46453469934797509</c:v>
                  </c:pt>
                  <c:pt idx="12">
                    <c:v>0</c:v>
                  </c:pt>
                  <c:pt idx="13">
                    <c:v>2.061965247105805</c:v>
                  </c:pt>
                  <c:pt idx="14">
                    <c:v>1.0322993318843874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 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3:$F$37</c:f>
              <c:numCache>
                <c:formatCode>0.0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5.435897435897438</c:v>
                </c:pt>
                <c:pt idx="7">
                  <c:v>34.205128205128204</c:v>
                </c:pt>
                <c:pt idx="8">
                  <c:v>26.379928315412187</c:v>
                </c:pt>
                <c:pt idx="9">
                  <c:v>64.102564102564102</c:v>
                </c:pt>
                <c:pt idx="10">
                  <c:v>23.869731800766285</c:v>
                </c:pt>
                <c:pt idx="11">
                  <c:v>23.601532567049805</c:v>
                </c:pt>
                <c:pt idx="12">
                  <c:v>0</c:v>
                </c:pt>
                <c:pt idx="13">
                  <c:v>23.80952380952381</c:v>
                </c:pt>
                <c:pt idx="14">
                  <c:v>25.3299276287782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0A3-4C61-BADD-AFE2708297C0}"/>
            </c:ext>
          </c:extLst>
        </c:ser>
        <c:ser>
          <c:idx val="4"/>
          <c:order val="2"/>
          <c:tx>
            <c:strRef>
              <c:f>Graph!$H$22</c:f>
              <c:strCache>
                <c:ptCount val="1"/>
                <c:pt idx="0">
                  <c:v>1 µg/ml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I$23:$I$37</c:f>
                <c:numCache>
                  <c:formatCode>General</c:formatCode>
                  <c:ptCount val="15"/>
                  <c:pt idx="0">
                    <c:v>3.6157679831302088</c:v>
                  </c:pt>
                  <c:pt idx="1">
                    <c:v>3.241939673688452</c:v>
                  </c:pt>
                  <c:pt idx="2">
                    <c:v>1.5156288034024912</c:v>
                  </c:pt>
                  <c:pt idx="3">
                    <c:v>0</c:v>
                  </c:pt>
                  <c:pt idx="4">
                    <c:v>0.41121814044845062</c:v>
                  </c:pt>
                  <c:pt idx="5">
                    <c:v>2.1285120887160889</c:v>
                  </c:pt>
                  <c:pt idx="6">
                    <c:v>0.17764623667373858</c:v>
                  </c:pt>
                  <c:pt idx="7">
                    <c:v>4.1746865618326927</c:v>
                  </c:pt>
                  <c:pt idx="8">
                    <c:v>2.763113099958141</c:v>
                  </c:pt>
                  <c:pt idx="9">
                    <c:v>2.2205779584216421</c:v>
                  </c:pt>
                  <c:pt idx="10">
                    <c:v>1.7557761283355722</c:v>
                  </c:pt>
                  <c:pt idx="11">
                    <c:v>0.72998309897538949</c:v>
                  </c:pt>
                  <c:pt idx="12">
                    <c:v>1.9245008972987538</c:v>
                  </c:pt>
                  <c:pt idx="13">
                    <c:v>0</c:v>
                  </c:pt>
                  <c:pt idx="14">
                    <c:v>2.5361210742624896</c:v>
                  </c:pt>
                </c:numCache>
              </c:numRef>
            </c:plus>
            <c:minus>
              <c:numRef>
                <c:f>Graph!$I$23:$I$37</c:f>
                <c:numCache>
                  <c:formatCode>General</c:formatCode>
                  <c:ptCount val="15"/>
                  <c:pt idx="0">
                    <c:v>3.6157679831302088</c:v>
                  </c:pt>
                  <c:pt idx="1">
                    <c:v>3.241939673688452</c:v>
                  </c:pt>
                  <c:pt idx="2">
                    <c:v>1.5156288034024912</c:v>
                  </c:pt>
                  <c:pt idx="3">
                    <c:v>0</c:v>
                  </c:pt>
                  <c:pt idx="4">
                    <c:v>0.41121814044845062</c:v>
                  </c:pt>
                  <c:pt idx="5">
                    <c:v>2.1285120887160889</c:v>
                  </c:pt>
                  <c:pt idx="6">
                    <c:v>0.17764623667373858</c:v>
                  </c:pt>
                  <c:pt idx="7">
                    <c:v>4.1746865618326927</c:v>
                  </c:pt>
                  <c:pt idx="8">
                    <c:v>2.763113099958141</c:v>
                  </c:pt>
                  <c:pt idx="9">
                    <c:v>2.2205779584216421</c:v>
                  </c:pt>
                  <c:pt idx="10">
                    <c:v>1.7557761283355722</c:v>
                  </c:pt>
                  <c:pt idx="11">
                    <c:v>0.72998309897538949</c:v>
                  </c:pt>
                  <c:pt idx="12">
                    <c:v>1.9245008972987538</c:v>
                  </c:pt>
                  <c:pt idx="13">
                    <c:v>0</c:v>
                  </c:pt>
                  <c:pt idx="14">
                    <c:v>2.5361210742624896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 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3:$H$37</c:f>
              <c:numCache>
                <c:formatCode>0.0</c:formatCode>
                <c:ptCount val="15"/>
                <c:pt idx="0">
                  <c:v>30.610407047188655</c:v>
                </c:pt>
                <c:pt idx="1">
                  <c:v>35.425685425685423</c:v>
                </c:pt>
                <c:pt idx="2">
                  <c:v>34.826526130873958</c:v>
                </c:pt>
                <c:pt idx="3">
                  <c:v>20.833333333333336</c:v>
                </c:pt>
                <c:pt idx="4">
                  <c:v>18.993352326685656</c:v>
                </c:pt>
                <c:pt idx="5">
                  <c:v>19.55665024630542</c:v>
                </c:pt>
                <c:pt idx="6">
                  <c:v>92.20512820512819</c:v>
                </c:pt>
                <c:pt idx="7">
                  <c:v>85.589743589743591</c:v>
                </c:pt>
                <c:pt idx="8">
                  <c:v>67.060931899641574</c:v>
                </c:pt>
                <c:pt idx="9">
                  <c:v>97.435897435897417</c:v>
                </c:pt>
                <c:pt idx="10">
                  <c:v>67.049808429118784</c:v>
                </c:pt>
                <c:pt idx="11">
                  <c:v>62.911877394636015</c:v>
                </c:pt>
                <c:pt idx="12">
                  <c:v>57.777777777777771</c:v>
                </c:pt>
                <c:pt idx="13">
                  <c:v>71.428571428571431</c:v>
                </c:pt>
                <c:pt idx="14">
                  <c:v>67.5180928054491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0A3-4C61-BADD-AFE2708297C0}"/>
            </c:ext>
          </c:extLst>
        </c:ser>
        <c:ser>
          <c:idx val="6"/>
          <c:order val="3"/>
          <c:tx>
            <c:strRef>
              <c:f>Graph!$J$22</c:f>
              <c:strCache>
                <c:ptCount val="1"/>
                <c:pt idx="0">
                  <c:v>0.5 µg/ml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3:$K$37</c:f>
                <c:numCache>
                  <c:formatCode>General</c:formatCode>
                  <c:ptCount val="15"/>
                  <c:pt idx="0">
                    <c:v>4.3698881509388565</c:v>
                  </c:pt>
                  <c:pt idx="1">
                    <c:v>2.314432169169613</c:v>
                  </c:pt>
                  <c:pt idx="2">
                    <c:v>3.4722862317280252</c:v>
                  </c:pt>
                  <c:pt idx="3">
                    <c:v>2.4056261216234436</c:v>
                  </c:pt>
                  <c:pt idx="4">
                    <c:v>1.2336544213453497</c:v>
                  </c:pt>
                  <c:pt idx="5">
                    <c:v>0.99543149860280367</c:v>
                  </c:pt>
                  <c:pt idx="6">
                    <c:v>0</c:v>
                  </c:pt>
                  <c:pt idx="7">
                    <c:v>2.2205779584216421</c:v>
                  </c:pt>
                  <c:pt idx="8">
                    <c:v>0.43456471874488639</c:v>
                  </c:pt>
                  <c:pt idx="9">
                    <c:v>2.2205779584216421</c:v>
                  </c:pt>
                  <c:pt idx="10">
                    <c:v>1.5263282978576365</c:v>
                  </c:pt>
                  <c:pt idx="11">
                    <c:v>1.4599661979507788</c:v>
                  </c:pt>
                  <c:pt idx="12">
                    <c:v>0</c:v>
                  </c:pt>
                  <c:pt idx="13">
                    <c:v>2.0619652471058134</c:v>
                  </c:pt>
                  <c:pt idx="14">
                    <c:v>1.2535063315739001</c:v>
                  </c:pt>
                </c:numCache>
              </c:numRef>
            </c:plus>
            <c:minus>
              <c:numRef>
                <c:f>Graph!$K$23:$K$37</c:f>
                <c:numCache>
                  <c:formatCode>General</c:formatCode>
                  <c:ptCount val="15"/>
                  <c:pt idx="0">
                    <c:v>4.3698881509388565</c:v>
                  </c:pt>
                  <c:pt idx="1">
                    <c:v>2.314432169169613</c:v>
                  </c:pt>
                  <c:pt idx="2">
                    <c:v>3.4722862317280252</c:v>
                  </c:pt>
                  <c:pt idx="3">
                    <c:v>2.4056261216234436</c:v>
                  </c:pt>
                  <c:pt idx="4">
                    <c:v>1.2336544213453497</c:v>
                  </c:pt>
                  <c:pt idx="5">
                    <c:v>0.99543149860280367</c:v>
                  </c:pt>
                  <c:pt idx="6">
                    <c:v>0</c:v>
                  </c:pt>
                  <c:pt idx="7">
                    <c:v>2.2205779584216421</c:v>
                  </c:pt>
                  <c:pt idx="8">
                    <c:v>0.43456471874488639</c:v>
                  </c:pt>
                  <c:pt idx="9">
                    <c:v>2.2205779584216421</c:v>
                  </c:pt>
                  <c:pt idx="10">
                    <c:v>1.5263282978576365</c:v>
                  </c:pt>
                  <c:pt idx="11">
                    <c:v>1.4599661979507788</c:v>
                  </c:pt>
                  <c:pt idx="12">
                    <c:v>0</c:v>
                  </c:pt>
                  <c:pt idx="13">
                    <c:v>2.0619652471058134</c:v>
                  </c:pt>
                  <c:pt idx="14">
                    <c:v>1.2535063315739001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 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3:$J$37</c:f>
              <c:numCache>
                <c:formatCode>0.0</c:formatCode>
                <c:ptCount val="15"/>
                <c:pt idx="0">
                  <c:v>45.274584929757339</c:v>
                </c:pt>
                <c:pt idx="1">
                  <c:v>66.161616161616152</c:v>
                </c:pt>
                <c:pt idx="2">
                  <c:v>58.042380324989018</c:v>
                </c:pt>
                <c:pt idx="3">
                  <c:v>38.888888888888893</c:v>
                </c:pt>
                <c:pt idx="4">
                  <c:v>43.019943019943021</c:v>
                </c:pt>
                <c:pt idx="5">
                  <c:v>49.425287356321839</c:v>
                </c:pt>
                <c:pt idx="6">
                  <c:v>100</c:v>
                </c:pt>
                <c:pt idx="7">
                  <c:v>98.717948717948715</c:v>
                </c:pt>
                <c:pt idx="8">
                  <c:v>76.917562724014331</c:v>
                </c:pt>
                <c:pt idx="9">
                  <c:v>106.41025641025641</c:v>
                </c:pt>
                <c:pt idx="10">
                  <c:v>78.429118773946357</c:v>
                </c:pt>
                <c:pt idx="11">
                  <c:v>74.17624521072797</c:v>
                </c:pt>
                <c:pt idx="12">
                  <c:v>73.333333333333343</c:v>
                </c:pt>
                <c:pt idx="13">
                  <c:v>84.523809523809533</c:v>
                </c:pt>
                <c:pt idx="14">
                  <c:v>80.757769263516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0A3-4C61-BADD-AFE2708297C0}"/>
            </c:ext>
          </c:extLst>
        </c:ser>
        <c:ser>
          <c:idx val="8"/>
          <c:order val="4"/>
          <c:tx>
            <c:strRef>
              <c:f>Graph!$L$22</c:f>
              <c:strCache>
                <c:ptCount val="1"/>
                <c:pt idx="0">
                  <c:v>0.1 µg/m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5A4D-46AA-8B5F-46D8343A2B2D}"/>
              </c:ext>
            </c:extLst>
          </c:dPt>
          <c:errBars>
            <c:errBarType val="both"/>
            <c:errValType val="cust"/>
            <c:noEndCap val="0"/>
            <c:plus>
              <c:numRef>
                <c:f>Graph!$M$23:$M$37</c:f>
                <c:numCache>
                  <c:formatCode>General</c:formatCode>
                  <c:ptCount val="15"/>
                  <c:pt idx="0">
                    <c:v>4.8382705893972826</c:v>
                  </c:pt>
                  <c:pt idx="1">
                    <c:v>2.8742545868747644</c:v>
                  </c:pt>
                  <c:pt idx="2">
                    <c:v>6.4075141970389096</c:v>
                  </c:pt>
                  <c:pt idx="3">
                    <c:v>2.4056261216234436</c:v>
                  </c:pt>
                  <c:pt idx="4">
                    <c:v>0.41121814044845678</c:v>
                  </c:pt>
                  <c:pt idx="5">
                    <c:v>3.0958514387683875</c:v>
                  </c:pt>
                  <c:pt idx="6">
                    <c:v>2.100061049173672</c:v>
                  </c:pt>
                  <c:pt idx="7">
                    <c:v>2.2259009655600726</c:v>
                  </c:pt>
                  <c:pt idx="8">
                    <c:v>6.208067410641234E-2</c:v>
                  </c:pt>
                  <c:pt idx="9">
                    <c:v>2.2205779584216421</c:v>
                  </c:pt>
                  <c:pt idx="10">
                    <c:v>2.057225097112465</c:v>
                  </c:pt>
                  <c:pt idx="11">
                    <c:v>4.0480880943180733</c:v>
                  </c:pt>
                  <c:pt idx="12">
                    <c:v>0</c:v>
                  </c:pt>
                  <c:pt idx="13">
                    <c:v>2.061965247105805</c:v>
                  </c:pt>
                  <c:pt idx="14">
                    <c:v>3.8321270806190868</c:v>
                  </c:pt>
                </c:numCache>
              </c:numRef>
            </c:plus>
            <c:minus>
              <c:numRef>
                <c:f>Graph!$M$23:$M$37</c:f>
                <c:numCache>
                  <c:formatCode>General</c:formatCode>
                  <c:ptCount val="15"/>
                  <c:pt idx="0">
                    <c:v>4.8382705893972826</c:v>
                  </c:pt>
                  <c:pt idx="1">
                    <c:v>2.8742545868747644</c:v>
                  </c:pt>
                  <c:pt idx="2">
                    <c:v>6.4075141970389096</c:v>
                  </c:pt>
                  <c:pt idx="3">
                    <c:v>2.4056261216234436</c:v>
                  </c:pt>
                  <c:pt idx="4">
                    <c:v>0.41121814044845678</c:v>
                  </c:pt>
                  <c:pt idx="5">
                    <c:v>3.0958514387683875</c:v>
                  </c:pt>
                  <c:pt idx="6">
                    <c:v>2.100061049173672</c:v>
                  </c:pt>
                  <c:pt idx="7">
                    <c:v>2.2259009655600726</c:v>
                  </c:pt>
                  <c:pt idx="8">
                    <c:v>6.208067410641234E-2</c:v>
                  </c:pt>
                  <c:pt idx="9">
                    <c:v>2.2205779584216421</c:v>
                  </c:pt>
                  <c:pt idx="10">
                    <c:v>2.057225097112465</c:v>
                  </c:pt>
                  <c:pt idx="11">
                    <c:v>4.0480880943180733</c:v>
                  </c:pt>
                  <c:pt idx="12">
                    <c:v>0</c:v>
                  </c:pt>
                  <c:pt idx="13">
                    <c:v>2.061965247105805</c:v>
                  </c:pt>
                  <c:pt idx="14">
                    <c:v>3.8321270806190868</c:v>
                  </c:pt>
                </c:numCache>
              </c:numRef>
            </c:minus>
          </c:errBars>
          <c:cat>
            <c:strRef>
              <c:f>Graph!$B$23:$B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 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23:$L$37</c:f>
              <c:numCache>
                <c:formatCode>0.0</c:formatCode>
                <c:ptCount val="15"/>
                <c:pt idx="0">
                  <c:v>87.985067295412122</c:v>
                </c:pt>
                <c:pt idx="1">
                  <c:v>106.20490620490618</c:v>
                </c:pt>
                <c:pt idx="2">
                  <c:v>92.93478260869567</c:v>
                </c:pt>
                <c:pt idx="3">
                  <c:v>81.944444444444443</c:v>
                </c:pt>
                <c:pt idx="4">
                  <c:v>81.006647673314333</c:v>
                </c:pt>
                <c:pt idx="5">
                  <c:v>89.726327312534224</c:v>
                </c:pt>
                <c:pt idx="6">
                  <c:v>112.97435897435896</c:v>
                </c:pt>
                <c:pt idx="7">
                  <c:v>106.56410256410255</c:v>
                </c:pt>
                <c:pt idx="8">
                  <c:v>103.29749103942652</c:v>
                </c:pt>
                <c:pt idx="9">
                  <c:v>106.41025641025641</c:v>
                </c:pt>
                <c:pt idx="10">
                  <c:v>105.70881226053639</c:v>
                </c:pt>
                <c:pt idx="11">
                  <c:v>105.67049808429118</c:v>
                </c:pt>
                <c:pt idx="12">
                  <c:v>100</c:v>
                </c:pt>
                <c:pt idx="13">
                  <c:v>104.76190476190477</c:v>
                </c:pt>
                <c:pt idx="14">
                  <c:v>107.322264793529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0A3-4C61-BADD-AFE2708297C0}"/>
            </c:ext>
          </c:extLst>
        </c:ser>
        <c:ser>
          <c:idx val="1"/>
          <c:order val="5"/>
          <c:tx>
            <c:strRef>
              <c:f>Graph!$C$22</c:f>
              <c:strCache>
                <c:ptCount val="1"/>
                <c:pt idx="0">
                  <c:v>0 µg/ml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C$23:$C$37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B0A3-4C61-BADD-AFE2708297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2633488"/>
        <c:axId val="352632312"/>
      </c:barChart>
      <c:catAx>
        <c:axId val="3526334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>
                <a:solidFill>
                  <a:sysClr val="windowText" lastClr="000000"/>
                </a:solidFill>
                <a:latin typeface="+mn-lt"/>
                <a:cs typeface="Times New Roman" panose="02020603050405020304" pitchFamily="18" charset="0"/>
              </a:defRPr>
            </a:pPr>
            <a:endParaRPr lang="it-IT"/>
          </a:p>
        </c:txPr>
        <c:crossAx val="352632312"/>
        <c:crossesAt val="0"/>
        <c:auto val="1"/>
        <c:lblAlgn val="ctr"/>
        <c:lblOffset val="100"/>
        <c:noMultiLvlLbl val="0"/>
      </c:catAx>
      <c:valAx>
        <c:axId val="352632312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sz="800"/>
                  <a:t>Colony diameter</a:t>
                </a:r>
                <a:r>
                  <a:rPr lang="en-GB" sz="800" baseline="0"/>
                  <a:t> (% relative to control)</a:t>
                </a:r>
                <a:endParaRPr lang="en-GB" sz="800"/>
              </a:p>
            </c:rich>
          </c:tx>
          <c:layout>
            <c:manualLayout>
              <c:xMode val="edge"/>
              <c:yMode val="edge"/>
              <c:x val="5.1679593573228828E-3"/>
              <c:y val="0.2913719743365412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52633488"/>
        <c:crosses val="autoZero"/>
        <c:crossBetween val="between"/>
      </c:valAx>
      <c:spPr>
        <a:noFill/>
      </c:spPr>
    </c:plotArea>
    <c:legend>
      <c:legendPos val="r"/>
      <c:layout>
        <c:manualLayout>
          <c:xMode val="edge"/>
          <c:yMode val="edge"/>
          <c:x val="0.92039850527966049"/>
          <c:y val="0.41110746573344997"/>
          <c:w val="7.9601494720339477E-2"/>
          <c:h val="0.17408136482939632"/>
        </c:manualLayout>
      </c:layout>
      <c:overlay val="0"/>
      <c:txPr>
        <a:bodyPr/>
        <a:lstStyle/>
        <a:p>
          <a:pPr>
            <a:defRPr sz="800">
              <a:latin typeface="+mn-lt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621</cdr:x>
      <cdr:y>0.55781</cdr:y>
    </cdr:from>
    <cdr:to>
      <cdr:x>0.08218</cdr:x>
      <cdr:y>0.59468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579584" y="4176130"/>
          <a:ext cx="139793" cy="276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073</cdr:x>
      <cdr:y>0.45407</cdr:y>
    </cdr:from>
    <cdr:to>
      <cdr:x>0.09354</cdr:x>
      <cdr:y>0.48547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639004" y="3399435"/>
          <a:ext cx="179796" cy="2350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7943</cdr:x>
      <cdr:y>0.16794</cdr:y>
    </cdr:from>
    <cdr:to>
      <cdr:x>0.0993</cdr:x>
      <cdr:y>0.20797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695326" y="1257300"/>
          <a:ext cx="173862" cy="2997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8815</cdr:x>
      <cdr:y>0.12452</cdr:y>
    </cdr:from>
    <cdr:to>
      <cdr:x>0.1121</cdr:x>
      <cdr:y>0.15183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771619" y="932242"/>
          <a:ext cx="209645" cy="2044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1998</cdr:x>
      <cdr:y>0.52615</cdr:y>
    </cdr:from>
    <cdr:to>
      <cdr:x>0.1428</cdr:x>
      <cdr:y>0.55619</cdr:y>
    </cdr:to>
    <cdr:sp macro="" textlink="">
      <cdr:nvSpPr>
        <cdr:cNvPr id="6" name="CasellaDiTesto 5"/>
        <cdr:cNvSpPr txBox="1"/>
      </cdr:nvSpPr>
      <cdr:spPr>
        <a:xfrm xmlns:a="http://schemas.openxmlformats.org/drawingml/2006/main">
          <a:off x="1050258" y="3939109"/>
          <a:ext cx="199754" cy="2248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2765</cdr:x>
      <cdr:y>0.32993</cdr:y>
    </cdr:from>
    <cdr:to>
      <cdr:x>0.1459</cdr:x>
      <cdr:y>0.35997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951991" y="2404076"/>
          <a:ext cx="136110" cy="21889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372</cdr:x>
      <cdr:y>0.06226</cdr:y>
    </cdr:from>
    <cdr:to>
      <cdr:x>0.15659</cdr:x>
      <cdr:y>0.08821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1200977" y="466144"/>
          <a:ext cx="169729" cy="1942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4642</cdr:x>
      <cdr:y>0.12213</cdr:y>
    </cdr:from>
    <cdr:to>
      <cdr:x>0.1839</cdr:x>
      <cdr:y>0.16756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1281726" y="914373"/>
          <a:ext cx="327999" cy="3401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7737</cdr:x>
      <cdr:y>0.53817</cdr:y>
    </cdr:from>
    <cdr:to>
      <cdr:x>0.20755</cdr:x>
      <cdr:y>0.58531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1552587" y="4029058"/>
          <a:ext cx="264180" cy="3529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8135</cdr:x>
      <cdr:y>0.37536</cdr:y>
    </cdr:from>
    <cdr:to>
      <cdr:x>0.20625</cdr:x>
      <cdr:y>0.40988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352490" y="2735087"/>
          <a:ext cx="185706" cy="2515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9151</cdr:x>
      <cdr:y>0.12595</cdr:y>
    </cdr:from>
    <cdr:to>
      <cdr:x>0.22228</cdr:x>
      <cdr:y>0.17783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676400" y="942975"/>
          <a:ext cx="269296" cy="3883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0223</cdr:x>
      <cdr:y>0.12451</cdr:y>
    </cdr:from>
    <cdr:to>
      <cdr:x>0.24785</cdr:x>
      <cdr:y>0.15455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1770176" y="932191"/>
          <a:ext cx="399334" cy="2248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3312</cdr:x>
      <cdr:y>0.64186</cdr:y>
    </cdr:from>
    <cdr:to>
      <cdr:x>0.25251</cdr:x>
      <cdr:y>0.66917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2040626" y="4805344"/>
          <a:ext cx="169730" cy="20446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4048</cdr:x>
      <cdr:y>0.50891</cdr:y>
    </cdr:from>
    <cdr:to>
      <cdr:x>0.26371</cdr:x>
      <cdr:y>0.54109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2105026" y="3810001"/>
          <a:ext cx="203360" cy="2409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6008</cdr:x>
      <cdr:y>0.30178</cdr:y>
    </cdr:from>
    <cdr:to>
      <cdr:x>0.27376</cdr:x>
      <cdr:y>0.33182</cdr:y>
    </cdr:to>
    <cdr:sp macro="" textlink="">
      <cdr:nvSpPr>
        <cdr:cNvPr id="16" name="CasellaDiTesto 15"/>
        <cdr:cNvSpPr txBox="1"/>
      </cdr:nvSpPr>
      <cdr:spPr>
        <a:xfrm xmlns:a="http://schemas.openxmlformats.org/drawingml/2006/main">
          <a:off x="2171700" y="2105025"/>
          <a:ext cx="114300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b</a:t>
          </a:r>
        </a:p>
      </cdr:txBody>
    </cdr:sp>
  </cdr:relSizeAnchor>
  <cdr:relSizeAnchor xmlns:cdr="http://schemas.openxmlformats.org/drawingml/2006/chartDrawing">
    <cdr:from>
      <cdr:x>0.25703</cdr:x>
      <cdr:y>0.1207</cdr:y>
    </cdr:from>
    <cdr:to>
      <cdr:x>0.28212</cdr:x>
      <cdr:y>0.14665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2249867" y="903650"/>
          <a:ext cx="219624" cy="1942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a</a:t>
          </a:r>
        </a:p>
      </cdr:txBody>
    </cdr:sp>
  </cdr:relSizeAnchor>
  <cdr:relSizeAnchor xmlns:cdr="http://schemas.openxmlformats.org/drawingml/2006/chartDrawing">
    <cdr:from>
      <cdr:x>0.28886</cdr:x>
      <cdr:y>0.65349</cdr:y>
    </cdr:from>
    <cdr:to>
      <cdr:x>0.31167</cdr:x>
      <cdr:y>0.68216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2528528" y="4892465"/>
          <a:ext cx="199667" cy="2146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9432</cdr:x>
      <cdr:y>0.48601</cdr:y>
    </cdr:from>
    <cdr:to>
      <cdr:x>0.32692</cdr:x>
      <cdr:y>0.53143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2195049" y="3541373"/>
          <a:ext cx="243134" cy="3309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0194</cdr:x>
      <cdr:y>0.24169</cdr:y>
    </cdr:from>
    <cdr:to>
      <cdr:x>0.33676</cdr:x>
      <cdr:y>0.29938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2251880" y="1761125"/>
          <a:ext cx="259690" cy="4203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1427</cdr:x>
      <cdr:y>0.12306</cdr:y>
    </cdr:from>
    <cdr:to>
      <cdr:x>0.34168</cdr:x>
      <cdr:y>0.16129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2750938" y="921335"/>
          <a:ext cx="239912" cy="2862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4839</cdr:x>
      <cdr:y>0.64026</cdr:y>
    </cdr:from>
    <cdr:to>
      <cdr:x>0.36435</cdr:x>
      <cdr:y>0.67577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3049623" y="4793376"/>
          <a:ext cx="139705" cy="2658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5143</cdr:x>
      <cdr:y>0.44807</cdr:y>
    </cdr:from>
    <cdr:to>
      <cdr:x>0.37652</cdr:x>
      <cdr:y>0.48221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2620959" y="3264918"/>
          <a:ext cx="187123" cy="2487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5743</cdr:x>
      <cdr:y>0.16993</cdr:y>
    </cdr:from>
    <cdr:to>
      <cdr:x>0.39085</cdr:x>
      <cdr:y>0.20561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2665728" y="1238251"/>
          <a:ext cx="249249" cy="2599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9162</cdr:x>
      <cdr:y>0.52488</cdr:y>
    </cdr:from>
    <cdr:to>
      <cdr:x>0.40759</cdr:x>
      <cdr:y>0.55492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3428035" y="3929601"/>
          <a:ext cx="139793" cy="2248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9634</cdr:x>
      <cdr:y>0.47228</cdr:y>
    </cdr:from>
    <cdr:to>
      <cdr:x>0.4146</cdr:x>
      <cdr:y>0.51461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3469352" y="3535810"/>
          <a:ext cx="159838" cy="3169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0215</cdr:x>
      <cdr:y>0.1744</cdr:y>
    </cdr:from>
    <cdr:to>
      <cdr:x>0.42382</cdr:x>
      <cdr:y>0.20444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3520210" y="1305645"/>
          <a:ext cx="189687" cy="2248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191</cdr:x>
      <cdr:y>0.02294</cdr:y>
    </cdr:from>
    <cdr:to>
      <cdr:x>0.44761</cdr:x>
      <cdr:y>0.05434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3668597" y="171776"/>
          <a:ext cx="249562" cy="2350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0729</cdr:x>
      <cdr:y>0.12175</cdr:y>
    </cdr:from>
    <cdr:to>
      <cdr:x>0.43125</cdr:x>
      <cdr:y>0.15452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3037588" y="887167"/>
          <a:ext cx="178695" cy="238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2947</cdr:x>
      <cdr:y>0.12151</cdr:y>
    </cdr:from>
    <cdr:to>
      <cdr:x>0.45115</cdr:x>
      <cdr:y>0.15838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3759338" y="909680"/>
          <a:ext cx="189776" cy="276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4396</cdr:x>
      <cdr:y>0.58651</cdr:y>
    </cdr:from>
    <cdr:to>
      <cdr:x>0.47556</cdr:x>
      <cdr:y>0.63117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3886160" y="4390989"/>
          <a:ext cx="276610" cy="3343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5158</cdr:x>
      <cdr:y>0.54072</cdr:y>
    </cdr:from>
    <cdr:to>
      <cdr:x>0.49163</cdr:x>
      <cdr:y>0.58531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3952894" y="4048149"/>
          <a:ext cx="350576" cy="3338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5919</cdr:x>
      <cdr:y>0.18957</cdr:y>
    </cdr:from>
    <cdr:to>
      <cdr:x>0.49479</cdr:x>
      <cdr:y>0.23199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4019551" y="1419226"/>
          <a:ext cx="311588" cy="317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6681</cdr:x>
      <cdr:y>0.11705</cdr:y>
    </cdr:from>
    <cdr:to>
      <cdr:x>0.50371</cdr:x>
      <cdr:y>0.17007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4086226" y="876300"/>
          <a:ext cx="323016" cy="3969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7651</cdr:x>
      <cdr:y>0.06844</cdr:y>
    </cdr:from>
    <cdr:to>
      <cdr:x>0.50046</cdr:x>
      <cdr:y>0.09985</cdr:y>
    </cdr:to>
    <cdr:sp macro="" textlink="">
      <cdr:nvSpPr>
        <cdr:cNvPr id="36" name="CasellaDiTesto 35"/>
        <cdr:cNvSpPr txBox="1"/>
      </cdr:nvSpPr>
      <cdr:spPr>
        <a:xfrm xmlns:a="http://schemas.openxmlformats.org/drawingml/2006/main">
          <a:off x="4171102" y="512404"/>
          <a:ext cx="209645" cy="2351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8666</cdr:x>
      <cdr:y>0.12169</cdr:y>
    </cdr:from>
    <cdr:to>
      <cdr:x>0.50947</cdr:x>
      <cdr:y>0.15993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4259982" y="911045"/>
          <a:ext cx="199667" cy="2862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002</cdr:x>
      <cdr:y>0.65075</cdr:y>
    </cdr:from>
    <cdr:to>
      <cdr:x>0.52301</cdr:x>
      <cdr:y>0.68079</cdr:y>
    </cdr:to>
    <cdr:sp macro="" textlink="">
      <cdr:nvSpPr>
        <cdr:cNvPr id="38" name="CasellaDiTesto 37"/>
        <cdr:cNvSpPr txBox="1"/>
      </cdr:nvSpPr>
      <cdr:spPr>
        <a:xfrm xmlns:a="http://schemas.openxmlformats.org/drawingml/2006/main">
          <a:off x="4378471" y="4871969"/>
          <a:ext cx="199667" cy="2248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0657</cdr:x>
      <cdr:y>0.60227</cdr:y>
    </cdr:from>
    <cdr:to>
      <cdr:x>0.53623</cdr:x>
      <cdr:y>0.63352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3778004" y="4388484"/>
          <a:ext cx="221207" cy="2277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1612</cdr:x>
      <cdr:y>0.32047</cdr:y>
    </cdr:from>
    <cdr:to>
      <cdr:x>0.53665</cdr:x>
      <cdr:y>0.35187</cdr:y>
    </cdr:to>
    <cdr:sp macro="" textlink="">
      <cdr:nvSpPr>
        <cdr:cNvPr id="40" name="CasellaDiTesto 39"/>
        <cdr:cNvSpPr txBox="1"/>
      </cdr:nvSpPr>
      <cdr:spPr>
        <a:xfrm xmlns:a="http://schemas.openxmlformats.org/drawingml/2006/main">
          <a:off x="4517827" y="2399256"/>
          <a:ext cx="179709" cy="2350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4209</cdr:x>
      <cdr:y>0.12341</cdr:y>
    </cdr:from>
    <cdr:to>
      <cdr:x>0.57671</cdr:x>
      <cdr:y>0.15325</cdr:y>
    </cdr:to>
    <cdr:sp macro="" textlink="">
      <cdr:nvSpPr>
        <cdr:cNvPr id="42" name="CasellaDiTesto 41"/>
        <cdr:cNvSpPr txBox="1"/>
      </cdr:nvSpPr>
      <cdr:spPr>
        <a:xfrm xmlns:a="http://schemas.openxmlformats.org/drawingml/2006/main">
          <a:off x="4745127" y="923925"/>
          <a:ext cx="303123" cy="2233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3287</cdr:x>
      <cdr:y>0.10051</cdr:y>
    </cdr:from>
    <cdr:to>
      <cdr:x>0.56252</cdr:x>
      <cdr:y>0.14122</cdr:y>
    </cdr:to>
    <cdr:sp macro="" textlink="">
      <cdr:nvSpPr>
        <cdr:cNvPr id="43" name="CasellaDiTesto 42"/>
        <cdr:cNvSpPr txBox="1"/>
      </cdr:nvSpPr>
      <cdr:spPr>
        <a:xfrm xmlns:a="http://schemas.openxmlformats.org/drawingml/2006/main">
          <a:off x="4664506" y="752476"/>
          <a:ext cx="259541" cy="3047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5744</cdr:x>
      <cdr:y>0.40331</cdr:y>
    </cdr:from>
    <cdr:to>
      <cdr:x>0.58868</cdr:x>
      <cdr:y>0.43942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4879537" y="3019425"/>
          <a:ext cx="273488" cy="2703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6225</cdr:x>
      <cdr:y>0.32644</cdr:y>
    </cdr:from>
    <cdr:to>
      <cdr:x>0.6113</cdr:x>
      <cdr:y>0.38246</cdr:y>
    </cdr:to>
    <cdr:sp macro="" textlink="">
      <cdr:nvSpPr>
        <cdr:cNvPr id="45" name="CasellaDiTesto 44"/>
        <cdr:cNvSpPr txBox="1"/>
      </cdr:nvSpPr>
      <cdr:spPr>
        <a:xfrm xmlns:a="http://schemas.openxmlformats.org/drawingml/2006/main" rot="16200000">
          <a:off x="4926657" y="2438984"/>
          <a:ext cx="419402" cy="4293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56663</cdr:x>
      <cdr:y>0.11755</cdr:y>
    </cdr:from>
    <cdr:to>
      <cdr:x>0.59115</cdr:x>
      <cdr:y>0.16289</cdr:y>
    </cdr:to>
    <cdr:sp macro="" textlink="">
      <cdr:nvSpPr>
        <cdr:cNvPr id="46" name="CasellaDiTesto 45"/>
        <cdr:cNvSpPr txBox="1"/>
      </cdr:nvSpPr>
      <cdr:spPr>
        <a:xfrm xmlns:a="http://schemas.openxmlformats.org/drawingml/2006/main" rot="16200000">
          <a:off x="4138884" y="910611"/>
          <a:ext cx="323897" cy="1821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57455</cdr:x>
      <cdr:y>0.06528</cdr:y>
    </cdr:from>
    <cdr:to>
      <cdr:x>0.63501</cdr:x>
      <cdr:y>0.09259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5029276" y="488720"/>
          <a:ext cx="529235" cy="2044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 </a:t>
          </a:r>
          <a:r>
            <a:rPr lang="fr-FR" sz="1000"/>
            <a:t>a  a</a:t>
          </a:r>
        </a:p>
      </cdr:txBody>
    </cdr:sp>
  </cdr:relSizeAnchor>
  <cdr:relSizeAnchor xmlns:cdr="http://schemas.openxmlformats.org/drawingml/2006/chartDrawing">
    <cdr:from>
      <cdr:x>0.59586</cdr:x>
      <cdr:y>0.11427</cdr:y>
    </cdr:from>
    <cdr:to>
      <cdr:x>0.63089</cdr:x>
      <cdr:y>0.15961</cdr:y>
    </cdr:to>
    <cdr:sp macro="" textlink="">
      <cdr:nvSpPr>
        <cdr:cNvPr id="48" name="CasellaDiTesto 47"/>
        <cdr:cNvSpPr txBox="1"/>
      </cdr:nvSpPr>
      <cdr:spPr>
        <a:xfrm xmlns:a="http://schemas.openxmlformats.org/drawingml/2006/main" rot="16200000">
          <a:off x="4395090" y="848114"/>
          <a:ext cx="323897" cy="2602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61871</cdr:x>
      <cdr:y>0.62222</cdr:y>
    </cdr:from>
    <cdr:to>
      <cdr:x>0.64723</cdr:x>
      <cdr:y>0.65226</cdr:y>
    </cdr:to>
    <cdr:sp macro="" textlink="">
      <cdr:nvSpPr>
        <cdr:cNvPr id="49" name="CasellaDiTesto 48"/>
        <cdr:cNvSpPr txBox="1"/>
      </cdr:nvSpPr>
      <cdr:spPr>
        <a:xfrm xmlns:a="http://schemas.openxmlformats.org/drawingml/2006/main">
          <a:off x="4614352" y="4533863"/>
          <a:ext cx="212705" cy="2188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62931</cdr:x>
      <cdr:y>0.32876</cdr:y>
    </cdr:from>
    <cdr:to>
      <cdr:x>0.64756</cdr:x>
      <cdr:y>0.35743</cdr:y>
    </cdr:to>
    <cdr:sp macro="" textlink="">
      <cdr:nvSpPr>
        <cdr:cNvPr id="50" name="CasellaDiTesto 49"/>
        <cdr:cNvSpPr txBox="1"/>
      </cdr:nvSpPr>
      <cdr:spPr>
        <a:xfrm xmlns:a="http://schemas.openxmlformats.org/drawingml/2006/main">
          <a:off x="5508616" y="2461304"/>
          <a:ext cx="159751" cy="2146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4418</cdr:x>
      <cdr:y>0.07379</cdr:y>
    </cdr:from>
    <cdr:to>
      <cdr:x>0.66814</cdr:x>
      <cdr:y>0.11077</cdr:y>
    </cdr:to>
    <cdr:sp macro="" textlink="">
      <cdr:nvSpPr>
        <cdr:cNvPr id="52" name="CasellaDiTesto 51"/>
        <cdr:cNvSpPr txBox="1"/>
      </cdr:nvSpPr>
      <cdr:spPr>
        <a:xfrm xmlns:a="http://schemas.openxmlformats.org/drawingml/2006/main">
          <a:off x="5638800" y="552450"/>
          <a:ext cx="209752" cy="2768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5455</cdr:x>
      <cdr:y>0.12443</cdr:y>
    </cdr:from>
    <cdr:to>
      <cdr:x>0.67737</cdr:x>
      <cdr:y>0.1531</cdr:y>
    </cdr:to>
    <cdr:sp macro="" textlink="">
      <cdr:nvSpPr>
        <cdr:cNvPr id="53" name="CasellaDiTesto 52"/>
        <cdr:cNvSpPr txBox="1"/>
      </cdr:nvSpPr>
      <cdr:spPr>
        <a:xfrm xmlns:a="http://schemas.openxmlformats.org/drawingml/2006/main">
          <a:off x="5729586" y="931575"/>
          <a:ext cx="199755" cy="2146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7934</cdr:x>
      <cdr:y>0.62296</cdr:y>
    </cdr:from>
    <cdr:to>
      <cdr:x>0.69645</cdr:x>
      <cdr:y>0.6571</cdr:y>
    </cdr:to>
    <cdr:sp macro="" textlink="">
      <cdr:nvSpPr>
        <cdr:cNvPr id="54" name="CasellaDiTesto 53"/>
        <cdr:cNvSpPr txBox="1"/>
      </cdr:nvSpPr>
      <cdr:spPr>
        <a:xfrm xmlns:a="http://schemas.openxmlformats.org/drawingml/2006/main">
          <a:off x="5066589" y="4539296"/>
          <a:ext cx="127607" cy="2487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8644</cdr:x>
      <cdr:y>0.3628</cdr:y>
    </cdr:from>
    <cdr:to>
      <cdr:x>0.70812</cdr:x>
      <cdr:y>0.38874</cdr:y>
    </cdr:to>
    <cdr:sp macro="" textlink="">
      <cdr:nvSpPr>
        <cdr:cNvPr id="55" name="CasellaDiTesto 54"/>
        <cdr:cNvSpPr txBox="1"/>
      </cdr:nvSpPr>
      <cdr:spPr>
        <a:xfrm xmlns:a="http://schemas.openxmlformats.org/drawingml/2006/main">
          <a:off x="6008773" y="2716142"/>
          <a:ext cx="189776" cy="1942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9097</cdr:x>
      <cdr:y>0.28244</cdr:y>
    </cdr:from>
    <cdr:to>
      <cdr:x>0.71926</cdr:x>
      <cdr:y>0.3271</cdr:y>
    </cdr:to>
    <cdr:sp macro="" textlink="">
      <cdr:nvSpPr>
        <cdr:cNvPr id="56" name="CasellaDiTesto 55"/>
        <cdr:cNvSpPr txBox="1"/>
      </cdr:nvSpPr>
      <cdr:spPr>
        <a:xfrm xmlns:a="http://schemas.openxmlformats.org/drawingml/2006/main">
          <a:off x="6048375" y="2114550"/>
          <a:ext cx="247677" cy="3343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0185</cdr:x>
      <cdr:y>0.05852</cdr:y>
    </cdr:from>
    <cdr:to>
      <cdr:x>0.75171</cdr:x>
      <cdr:y>0.09739</cdr:y>
    </cdr:to>
    <cdr:sp macro="" textlink="">
      <cdr:nvSpPr>
        <cdr:cNvPr id="57" name="CasellaDiTesto 56"/>
        <cdr:cNvSpPr txBox="1"/>
      </cdr:nvSpPr>
      <cdr:spPr>
        <a:xfrm xmlns:a="http://schemas.openxmlformats.org/drawingml/2006/main">
          <a:off x="6143626" y="438144"/>
          <a:ext cx="436448" cy="2910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1061</cdr:x>
      <cdr:y>0.12532</cdr:y>
    </cdr:from>
    <cdr:to>
      <cdr:x>0.73456</cdr:x>
      <cdr:y>0.15673</cdr:y>
    </cdr:to>
    <cdr:sp macro="" textlink="">
      <cdr:nvSpPr>
        <cdr:cNvPr id="58" name="CasellaDiTesto 57"/>
        <cdr:cNvSpPr txBox="1"/>
      </cdr:nvSpPr>
      <cdr:spPr>
        <a:xfrm xmlns:a="http://schemas.openxmlformats.org/drawingml/2006/main">
          <a:off x="6220322" y="938255"/>
          <a:ext cx="209646" cy="2351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4348</cdr:x>
      <cdr:y>0.38917</cdr:y>
    </cdr:from>
    <cdr:to>
      <cdr:x>0.76287</cdr:x>
      <cdr:y>0.41921</cdr:y>
    </cdr:to>
    <cdr:sp macro="" textlink="">
      <cdr:nvSpPr>
        <cdr:cNvPr id="59" name="CasellaDiTesto 58"/>
        <cdr:cNvSpPr txBox="1"/>
      </cdr:nvSpPr>
      <cdr:spPr>
        <a:xfrm xmlns:a="http://schemas.openxmlformats.org/drawingml/2006/main">
          <a:off x="6508017" y="2913616"/>
          <a:ext cx="169729" cy="2248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4864</cdr:x>
      <cdr:y>0.29644</cdr:y>
    </cdr:from>
    <cdr:to>
      <cdr:x>0.79506</cdr:x>
      <cdr:y>0.34048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6553201" y="2219335"/>
          <a:ext cx="406336" cy="3297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4944</cdr:x>
      <cdr:y>0.12278</cdr:y>
    </cdr:from>
    <cdr:to>
      <cdr:x>0.81788</cdr:x>
      <cdr:y>0.15965</cdr:y>
    </cdr:to>
    <cdr:sp macro="" textlink="">
      <cdr:nvSpPr>
        <cdr:cNvPr id="61" name="CasellaDiTesto 60"/>
        <cdr:cNvSpPr txBox="1"/>
      </cdr:nvSpPr>
      <cdr:spPr>
        <a:xfrm xmlns:a="http://schemas.openxmlformats.org/drawingml/2006/main">
          <a:off x="6560171" y="919222"/>
          <a:ext cx="599088" cy="276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  </a:t>
          </a:r>
          <a:r>
            <a:rPr lang="fr-FR" sz="1000"/>
            <a:t>a a</a:t>
          </a:r>
        </a:p>
      </cdr:txBody>
    </cdr:sp>
  </cdr:relSizeAnchor>
  <cdr:relSizeAnchor xmlns:cdr="http://schemas.openxmlformats.org/drawingml/2006/chartDrawing">
    <cdr:from>
      <cdr:x>0.84529</cdr:x>
      <cdr:y>0.60945</cdr:y>
    </cdr:from>
    <cdr:to>
      <cdr:x>0.88845</cdr:x>
      <cdr:y>0.64868</cdr:y>
    </cdr:to>
    <cdr:sp macro="" textlink="">
      <cdr:nvSpPr>
        <cdr:cNvPr id="62" name="CasellaDiTesto 61"/>
        <cdr:cNvSpPr txBox="1"/>
      </cdr:nvSpPr>
      <cdr:spPr>
        <a:xfrm xmlns:a="http://schemas.openxmlformats.org/drawingml/2006/main">
          <a:off x="6304256" y="4440813"/>
          <a:ext cx="321890" cy="2858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85164</cdr:x>
      <cdr:y>0.3192</cdr:y>
    </cdr:from>
    <cdr:to>
      <cdr:x>0.8917</cdr:x>
      <cdr:y>0.3539</cdr:y>
    </cdr:to>
    <cdr:sp macro="" textlink="">
      <cdr:nvSpPr>
        <cdr:cNvPr id="63" name="CasellaDiTesto 62"/>
        <cdr:cNvSpPr txBox="1"/>
      </cdr:nvSpPr>
      <cdr:spPr>
        <a:xfrm xmlns:a="http://schemas.openxmlformats.org/drawingml/2006/main">
          <a:off x="6351561" y="2325900"/>
          <a:ext cx="298771" cy="2528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6035</cdr:x>
      <cdr:y>0.24046</cdr:y>
    </cdr:from>
    <cdr:to>
      <cdr:x>0.91218</cdr:x>
      <cdr:y>0.28779</cdr:y>
    </cdr:to>
    <cdr:sp macro="" textlink="">
      <cdr:nvSpPr>
        <cdr:cNvPr id="64" name="CasellaDiTesto 63"/>
        <cdr:cNvSpPr txBox="1"/>
      </cdr:nvSpPr>
      <cdr:spPr>
        <a:xfrm xmlns:a="http://schemas.openxmlformats.org/drawingml/2006/main">
          <a:off x="6416521" y="1752142"/>
          <a:ext cx="386552" cy="3448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7052</cdr:x>
      <cdr:y>0.05143</cdr:y>
    </cdr:from>
    <cdr:to>
      <cdr:x>0.89105</cdr:x>
      <cdr:y>0.0883</cdr:y>
    </cdr:to>
    <cdr:sp macro="" textlink="">
      <cdr:nvSpPr>
        <cdr:cNvPr id="65" name="CasellaDiTesto 64"/>
        <cdr:cNvSpPr txBox="1"/>
      </cdr:nvSpPr>
      <cdr:spPr>
        <a:xfrm xmlns:a="http://schemas.openxmlformats.org/drawingml/2006/main">
          <a:off x="7620074" y="385071"/>
          <a:ext cx="179709" cy="276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a</a:t>
          </a:r>
        </a:p>
      </cdr:txBody>
    </cdr:sp>
  </cdr:relSizeAnchor>
  <cdr:relSizeAnchor xmlns:cdr="http://schemas.openxmlformats.org/drawingml/2006/chartDrawing">
    <cdr:from>
      <cdr:x>0.87975</cdr:x>
      <cdr:y>0.12468</cdr:y>
    </cdr:from>
    <cdr:to>
      <cdr:x>0.90751</cdr:x>
      <cdr:y>0.16338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7700830" y="933451"/>
          <a:ext cx="243020" cy="28968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4592</cdr:x>
      <cdr:y>0.22392</cdr:y>
    </cdr:from>
    <cdr:to>
      <cdr:x>0.26985</cdr:x>
      <cdr:y>0.27735</cdr:y>
    </cdr:to>
    <cdr:sp macro="" textlink="">
      <cdr:nvSpPr>
        <cdr:cNvPr id="67" name="TextBox 66"/>
        <cdr:cNvSpPr txBox="1"/>
      </cdr:nvSpPr>
      <cdr:spPr>
        <a:xfrm xmlns:a="http://schemas.openxmlformats.org/drawingml/2006/main">
          <a:off x="2152650" y="1676400"/>
          <a:ext cx="209514" cy="4000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3656</cdr:x>
      <cdr:y>0.25446</cdr:y>
    </cdr:from>
    <cdr:to>
      <cdr:x>0.65941</cdr:x>
      <cdr:y>0.29263</cdr:y>
    </cdr:to>
    <cdr:sp macro="" textlink="">
      <cdr:nvSpPr>
        <cdr:cNvPr id="68" name="TextBox 67"/>
        <cdr:cNvSpPr txBox="1"/>
      </cdr:nvSpPr>
      <cdr:spPr>
        <a:xfrm xmlns:a="http://schemas.openxmlformats.org/drawingml/2006/main">
          <a:off x="5572150" y="1905019"/>
          <a:ext cx="200017" cy="2857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2212</cdr:x>
      <cdr:y>0.26966</cdr:y>
    </cdr:from>
    <cdr:to>
      <cdr:x>0.54388</cdr:x>
      <cdr:y>0.31419</cdr:y>
    </cdr:to>
    <cdr:sp macro="" textlink="">
      <cdr:nvSpPr>
        <cdr:cNvPr id="69" name="TextBox 68"/>
        <cdr:cNvSpPr txBox="1"/>
      </cdr:nvSpPr>
      <cdr:spPr>
        <a:xfrm xmlns:a="http://schemas.openxmlformats.org/drawingml/2006/main">
          <a:off x="3894030" y="1964879"/>
          <a:ext cx="162288" cy="3244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7106</cdr:x>
      <cdr:y>0.12341</cdr:y>
    </cdr:from>
    <cdr:to>
      <cdr:x>0.39282</cdr:x>
      <cdr:y>0.15776</cdr:y>
    </cdr:to>
    <cdr:sp macro="" textlink="">
      <cdr:nvSpPr>
        <cdr:cNvPr id="70" name="TextBox 69">
          <a:extLst xmlns:a="http://schemas.openxmlformats.org/drawingml/2006/main">
            <a:ext uri="{FF2B5EF4-FFF2-40B4-BE49-F238E27FC236}">
              <a16:creationId xmlns:a16="http://schemas.microsoft.com/office/drawing/2014/main" xmlns="" id="{44CFF1C3-4E1F-4DC2-A917-D406C6B514B9}"/>
            </a:ext>
          </a:extLst>
        </cdr:cNvPr>
        <cdr:cNvSpPr txBox="1"/>
      </cdr:nvSpPr>
      <cdr:spPr>
        <a:xfrm xmlns:a="http://schemas.openxmlformats.org/drawingml/2006/main">
          <a:off x="3248025" y="923925"/>
          <a:ext cx="190500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0188</cdr:x>
      <cdr:y>0.21092</cdr:y>
    </cdr:from>
    <cdr:to>
      <cdr:x>0.83236</cdr:x>
      <cdr:y>0.24814</cdr:y>
    </cdr:to>
    <cdr:sp macro="" textlink="">
      <cdr:nvSpPr>
        <cdr:cNvPr id="71" name="TextBox 70">
          <a:extLst xmlns:a="http://schemas.openxmlformats.org/drawingml/2006/main">
            <a:ext uri="{FF2B5EF4-FFF2-40B4-BE49-F238E27FC236}">
              <a16:creationId xmlns:a16="http://schemas.microsoft.com/office/drawing/2014/main" xmlns="" id="{2143B567-B956-4427-8747-C748BC817B15}"/>
            </a:ext>
          </a:extLst>
        </cdr:cNvPr>
        <cdr:cNvSpPr txBox="1"/>
      </cdr:nvSpPr>
      <cdr:spPr>
        <a:xfrm xmlns:a="http://schemas.openxmlformats.org/drawingml/2006/main">
          <a:off x="6515100" y="1619250"/>
          <a:ext cx="247650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9719</cdr:x>
      <cdr:y>0.31017</cdr:y>
    </cdr:from>
    <cdr:to>
      <cdr:x>0.84291</cdr:x>
      <cdr:y>0.34615</cdr:y>
    </cdr:to>
    <cdr:sp macro="" textlink="">
      <cdr:nvSpPr>
        <cdr:cNvPr id="72" name="TextBox 71">
          <a:extLst xmlns:a="http://schemas.openxmlformats.org/drawingml/2006/main">
            <a:ext uri="{FF2B5EF4-FFF2-40B4-BE49-F238E27FC236}">
              <a16:creationId xmlns:a16="http://schemas.microsoft.com/office/drawing/2014/main" xmlns="" id="{369BE194-DC97-465C-814E-E94DD1B94B53}"/>
            </a:ext>
          </a:extLst>
        </cdr:cNvPr>
        <cdr:cNvSpPr txBox="1"/>
      </cdr:nvSpPr>
      <cdr:spPr>
        <a:xfrm xmlns:a="http://schemas.openxmlformats.org/drawingml/2006/main">
          <a:off x="6477001" y="2381250"/>
          <a:ext cx="371474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1477</cdr:x>
      <cdr:y>0.07816</cdr:y>
    </cdr:from>
    <cdr:to>
      <cdr:x>0.85463</cdr:x>
      <cdr:y>0.12035</cdr:y>
    </cdr:to>
    <cdr:sp macro="" textlink="">
      <cdr:nvSpPr>
        <cdr:cNvPr id="73" name="TextBox 72">
          <a:extLst xmlns:a="http://schemas.openxmlformats.org/drawingml/2006/main">
            <a:ext uri="{FF2B5EF4-FFF2-40B4-BE49-F238E27FC236}">
              <a16:creationId xmlns:a16="http://schemas.microsoft.com/office/drawing/2014/main" xmlns="" id="{F394DAC6-30E0-4AF3-817E-54FBD5CD027A}"/>
            </a:ext>
          </a:extLst>
        </cdr:cNvPr>
        <cdr:cNvSpPr txBox="1"/>
      </cdr:nvSpPr>
      <cdr:spPr>
        <a:xfrm xmlns:a="http://schemas.openxmlformats.org/drawingml/2006/main">
          <a:off x="6619875" y="600075"/>
          <a:ext cx="323850" cy="323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9015</cdr:x>
      <cdr:y>0.61414</cdr:y>
    </cdr:from>
    <cdr:to>
      <cdr:x>0.81125</cdr:x>
      <cdr:y>0.64764</cdr:y>
    </cdr:to>
    <cdr:sp macro="" textlink="">
      <cdr:nvSpPr>
        <cdr:cNvPr id="74" name="TextBox 73">
          <a:extLst xmlns:a="http://schemas.openxmlformats.org/drawingml/2006/main">
            <a:ext uri="{FF2B5EF4-FFF2-40B4-BE49-F238E27FC236}">
              <a16:creationId xmlns:a16="http://schemas.microsoft.com/office/drawing/2014/main" xmlns="" id="{AE4613CC-E619-4B84-A242-68884473590F}"/>
            </a:ext>
          </a:extLst>
        </cdr:cNvPr>
        <cdr:cNvSpPr txBox="1"/>
      </cdr:nvSpPr>
      <cdr:spPr>
        <a:xfrm xmlns:a="http://schemas.openxmlformats.org/drawingml/2006/main">
          <a:off x="6419850" y="4714875"/>
          <a:ext cx="171450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2436</cdr:x>
      <cdr:y>0.124</cdr:y>
    </cdr:from>
    <cdr:to>
      <cdr:x>0.84744</cdr:x>
      <cdr:y>0.15067</cdr:y>
    </cdr:to>
    <cdr:sp macro="" textlink="">
      <cdr:nvSpPr>
        <cdr:cNvPr id="75" name="TextBox 74">
          <a:extLst xmlns:a="http://schemas.openxmlformats.org/drawingml/2006/main">
            <a:ext uri="{FF2B5EF4-FFF2-40B4-BE49-F238E27FC236}">
              <a16:creationId xmlns:a16="http://schemas.microsoft.com/office/drawing/2014/main" xmlns="" id="{7EBB16BB-5C20-4F0B-B89D-661CCB14735A}"/>
            </a:ext>
          </a:extLst>
        </cdr:cNvPr>
        <cdr:cNvSpPr txBox="1"/>
      </cdr:nvSpPr>
      <cdr:spPr>
        <a:xfrm xmlns:a="http://schemas.openxmlformats.org/drawingml/2006/main">
          <a:off x="6124574" y="885825"/>
          <a:ext cx="171450" cy="1905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6156176" y="-34529"/>
            <a:ext cx="29878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smtClean="0"/>
              <a:t>Terbinafine</a:t>
            </a:r>
            <a:endParaRPr lang="en-GB" b="1" dirty="0"/>
          </a:p>
        </p:txBody>
      </p:sp>
      <p:graphicFrame>
        <p:nvGraphicFramePr>
          <p:cNvPr id="3" name="Grafico 2">
            <a:extLst>
              <a:ext uri="{FF2B5EF4-FFF2-40B4-BE49-F238E27FC236}">
                <a16:creationId xmlns:lc="http://schemas.openxmlformats.org/drawingml/2006/lockedCanvas" xmlns:a16="http://schemas.microsoft.com/office/drawing/2014/main" xmlns="" xmlns:xdr="http://schemas.openxmlformats.org/drawingml/2006/spreadsheetDrawing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2132563"/>
              </p:ext>
            </p:extLst>
          </p:nvPr>
        </p:nvGraphicFramePr>
        <p:xfrm>
          <a:off x="737484" y="485964"/>
          <a:ext cx="6727203" cy="62101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7416303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</TotalTime>
  <Words>83</Words>
  <Application>Microsoft Office PowerPoint</Application>
  <PresentationFormat>Presentazione su schermo (4:3)</PresentationFormat>
  <Paragraphs>7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5</cp:revision>
  <dcterms:created xsi:type="dcterms:W3CDTF">2019-06-04T18:45:56Z</dcterms:created>
  <dcterms:modified xsi:type="dcterms:W3CDTF">2019-08-20T09:20:50Z</dcterms:modified>
</cp:coreProperties>
</file>